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宮尾 安藝雄" initials="宮尾" lastIdx="1" clrIdx="0">
    <p:extLst>
      <p:ext uri="{19B8F6BF-5375-455C-9EA6-DF929625EA0E}">
        <p15:presenceInfo xmlns:p15="http://schemas.microsoft.com/office/powerpoint/2012/main" userId="980aa331686f292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144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4781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9221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1673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42605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6299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1664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6201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6577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67922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0183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7610F-5C30-4C02-9866-FC0E8D83C73B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19952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7610F-5C30-4C02-9866-FC0E8D83C73B}" type="datetimeFigureOut">
              <a:rPr kumimoji="1" lang="ja-JP" altLang="en-US" smtClean="0"/>
              <a:t>2022/6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5B1C6B-BB9A-4DD8-AA07-CB9C9AC9BD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0510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2105ED61-1DE8-4262-B76E-AEF15723D2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1063" y="508620"/>
            <a:ext cx="4319238" cy="18864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1DCC5CDB-A884-4F13-B9F2-EF59FF0B94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54417" y="508620"/>
            <a:ext cx="4304984" cy="18864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90B52D9A-3DFD-4B96-A59D-BF3DCD26C32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4252" y="3018903"/>
            <a:ext cx="4292861" cy="188640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DEC53E7B-9AC4-463C-92B2-03F3D662567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30109" y="3018903"/>
            <a:ext cx="4353601" cy="1886400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AA55692-5030-44AA-B2B7-346144EC0527}"/>
              </a:ext>
            </a:extLst>
          </p:cNvPr>
          <p:cNvSpPr txBox="1"/>
          <p:nvPr/>
        </p:nvSpPr>
        <p:spPr>
          <a:xfrm>
            <a:off x="1384917" y="5071432"/>
            <a:ext cx="7164280" cy="15179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Figure S2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游明朝" panose="02020400000000000000" pitchFamily="18" charset="-128"/>
            </a:endParaRPr>
          </a:p>
          <a:p>
            <a:pPr algn="just"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TE transpositions in RILs of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Drosophila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melanogaster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. Insertion positions of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P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,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FB4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,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Hobo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 and </a:t>
            </a:r>
            <a:r>
              <a:rPr lang="en-US" altLang="ja-JP" sz="1200" i="1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roo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 elements detected by TEF are indicated with vertical lines in red for accession SRR82377 from RIL46 (WE70/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yw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) and blue for SRR82382 from RIL80 (WE70/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yw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游明朝" panose="02020400000000000000" pitchFamily="18" charset="-128"/>
              </a:rPr>
              <a:t>). 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游明朝" panose="02020400000000000000" pitchFamily="18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56706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71</TotalTime>
  <Words>52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尾 安藝雄</dc:creator>
  <cp:lastModifiedBy>宮尾 安藝雄</cp:lastModifiedBy>
  <cp:revision>57</cp:revision>
  <dcterms:created xsi:type="dcterms:W3CDTF">2021-08-02T08:50:08Z</dcterms:created>
  <dcterms:modified xsi:type="dcterms:W3CDTF">2022-06-02T05:05:35Z</dcterms:modified>
</cp:coreProperties>
</file>